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67" d="100"/>
          <a:sy n="167" d="100"/>
        </p:scale>
        <p:origin x="1668" y="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D$4</c:f>
              <c:strCache>
                <c:ptCount val="1"/>
                <c:pt idx="0">
                  <c:v>Aveg 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5:$E$9</c:f>
                <c:numCache>
                  <c:formatCode>General</c:formatCode>
                  <c:ptCount val="5"/>
                  <c:pt idx="0">
                    <c:v>8.1649658092772678E-2</c:v>
                  </c:pt>
                  <c:pt idx="1">
                    <c:v>4.2999999999999997E-2</c:v>
                  </c:pt>
                  <c:pt idx="2">
                    <c:v>9.7140452079103198E-2</c:v>
                  </c:pt>
                  <c:pt idx="3">
                    <c:v>0.1</c:v>
                  </c:pt>
                  <c:pt idx="4">
                    <c:v>5.2624669291337203E-2</c:v>
                  </c:pt>
                </c:numCache>
              </c:numRef>
            </c:plus>
            <c:minus>
              <c:numRef>
                <c:f>Sheet1!$E$5:$E$9</c:f>
                <c:numCache>
                  <c:formatCode>General</c:formatCode>
                  <c:ptCount val="5"/>
                  <c:pt idx="0">
                    <c:v>8.1649658092772678E-2</c:v>
                  </c:pt>
                  <c:pt idx="1">
                    <c:v>4.2999999999999997E-2</c:v>
                  </c:pt>
                  <c:pt idx="2">
                    <c:v>9.7140452079103198E-2</c:v>
                  </c:pt>
                  <c:pt idx="3">
                    <c:v>0.1</c:v>
                  </c:pt>
                  <c:pt idx="4">
                    <c:v>5.2624669291337203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C$5:$C$9</c:f>
              <c:strCache>
                <c:ptCount val="5"/>
                <c:pt idx="0">
                  <c:v>WT</c:v>
                </c:pt>
                <c:pt idx="1">
                  <c:v>∆flaAD</c:v>
                </c:pt>
                <c:pt idx="2">
                  <c:v>∆flaABCD</c:v>
                </c:pt>
                <c:pt idx="3">
                  <c:v>∆flaAD+flaALas</c:v>
                </c:pt>
                <c:pt idx="4">
                  <c:v>∆flaABCD+flaALas</c:v>
                </c:pt>
              </c:strCache>
            </c:strRef>
          </c:cat>
          <c:val>
            <c:numRef>
              <c:f>Sheet1!$D$5:$D$9</c:f>
              <c:numCache>
                <c:formatCode>General</c:formatCode>
                <c:ptCount val="5"/>
                <c:pt idx="0">
                  <c:v>3.1</c:v>
                </c:pt>
                <c:pt idx="1">
                  <c:v>0.3</c:v>
                </c:pt>
                <c:pt idx="2">
                  <c:v>0.33333333333333331</c:v>
                </c:pt>
                <c:pt idx="3">
                  <c:v>2.1</c:v>
                </c:pt>
                <c:pt idx="4">
                  <c:v>0.313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A8B-40FE-8427-5F191EF619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74641712"/>
        <c:axId val="274643280"/>
      </c:barChart>
      <c:catAx>
        <c:axId val="274641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74643280"/>
        <c:crosses val="autoZero"/>
        <c:auto val="1"/>
        <c:lblAlgn val="ctr"/>
        <c:lblOffset val="100"/>
        <c:noMultiLvlLbl val="0"/>
      </c:catAx>
      <c:valAx>
        <c:axId val="2746432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800" b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wimminjg</a:t>
                </a:r>
                <a:r>
                  <a:rPr lang="en-US" sz="1800" b="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cm)</a:t>
                </a:r>
                <a:endParaRPr lang="en-US" sz="1800" b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46417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0FA6F-8409-4A49-B265-211C840AAE60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7488B-D9C2-468F-835F-A9013AB244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67552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0FA6F-8409-4A49-B265-211C840AAE60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7488B-D9C2-468F-835F-A9013AB244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1798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0FA6F-8409-4A49-B265-211C840AAE60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7488B-D9C2-468F-835F-A9013AB244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454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0FA6F-8409-4A49-B265-211C840AAE60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7488B-D9C2-468F-835F-A9013AB244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147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0FA6F-8409-4A49-B265-211C840AAE60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7488B-D9C2-468F-835F-A9013AB244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42233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0FA6F-8409-4A49-B265-211C840AAE60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7488B-D9C2-468F-835F-A9013AB244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6602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0FA6F-8409-4A49-B265-211C840AAE60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7488B-D9C2-468F-835F-A9013AB244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1688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0FA6F-8409-4A49-B265-211C840AAE60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7488B-D9C2-468F-835F-A9013AB244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3929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0FA6F-8409-4A49-B265-211C840AAE60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7488B-D9C2-468F-835F-A9013AB244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98463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0FA6F-8409-4A49-B265-211C840AAE60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7488B-D9C2-468F-835F-A9013AB244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38808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0FA6F-8409-4A49-B265-211C840AAE60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7488B-D9C2-468F-835F-A9013AB244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8561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F0FA6F-8409-4A49-B265-211C840AAE60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B7488B-D9C2-468F-835F-A9013AB244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5177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13">
            <a:extLst>
              <a:ext uri="{FF2B5EF4-FFF2-40B4-BE49-F238E27FC236}">
                <a16:creationId xmlns:a16="http://schemas.microsoft.com/office/drawing/2014/main" id="{FA048A40-26F7-4DC7-89F7-5A476F99EB1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6911751"/>
              </p:ext>
            </p:extLst>
          </p:nvPr>
        </p:nvGraphicFramePr>
        <p:xfrm>
          <a:off x="2276062" y="1054642"/>
          <a:ext cx="4810538" cy="33111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CaixaDeTexto 5">
            <a:extLst>
              <a:ext uri="{FF2B5EF4-FFF2-40B4-BE49-F238E27FC236}">
                <a16:creationId xmlns:a16="http://schemas.microsoft.com/office/drawing/2014/main" id="{608CADD1-1794-4F51-81BB-E2CB3C95DEF6}"/>
              </a:ext>
            </a:extLst>
          </p:cNvPr>
          <p:cNvSpPr txBox="1"/>
          <p:nvPr/>
        </p:nvSpPr>
        <p:spPr>
          <a:xfrm>
            <a:off x="6418330" y="2592226"/>
            <a:ext cx="186002" cy="276999"/>
          </a:xfrm>
          <a:prstGeom prst="rect">
            <a:avLst/>
          </a:prstGeom>
          <a:noFill/>
        </p:spPr>
        <p:txBody>
          <a:bodyPr wrap="none" rtlCol="0">
            <a:noAutofit/>
          </a:bodyPr>
          <a:lstStyle/>
          <a:p>
            <a:r>
              <a:rPr lang="en-US" sz="1350" dirty="0"/>
              <a:t>*</a:t>
            </a:r>
          </a:p>
        </p:txBody>
      </p:sp>
      <p:sp>
        <p:nvSpPr>
          <p:cNvPr id="7" name="CaixaDeTexto 6">
            <a:extLst>
              <a:ext uri="{FF2B5EF4-FFF2-40B4-BE49-F238E27FC236}">
                <a16:creationId xmlns:a16="http://schemas.microsoft.com/office/drawing/2014/main" id="{8CB5FF11-B625-4BE1-B18B-405CEA431FDD}"/>
              </a:ext>
            </a:extLst>
          </p:cNvPr>
          <p:cNvSpPr txBox="1"/>
          <p:nvPr/>
        </p:nvSpPr>
        <p:spPr>
          <a:xfrm>
            <a:off x="4865206" y="2563940"/>
            <a:ext cx="27122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/>
              <a:t>*</a:t>
            </a:r>
          </a:p>
        </p:txBody>
      </p:sp>
      <p:sp>
        <p:nvSpPr>
          <p:cNvPr id="8" name="CaixaDeTexto 7">
            <a:extLst>
              <a:ext uri="{FF2B5EF4-FFF2-40B4-BE49-F238E27FC236}">
                <a16:creationId xmlns:a16="http://schemas.microsoft.com/office/drawing/2014/main" id="{2B432C55-2EBF-4A8E-8318-F9FF34304C5E}"/>
              </a:ext>
            </a:extLst>
          </p:cNvPr>
          <p:cNvSpPr txBox="1"/>
          <p:nvPr/>
        </p:nvSpPr>
        <p:spPr>
          <a:xfrm>
            <a:off x="4101538" y="2598206"/>
            <a:ext cx="186002" cy="276999"/>
          </a:xfrm>
          <a:prstGeom prst="rect">
            <a:avLst/>
          </a:prstGeom>
          <a:noFill/>
        </p:spPr>
        <p:txBody>
          <a:bodyPr wrap="none" rtlCol="0">
            <a:noAutofit/>
          </a:bodyPr>
          <a:lstStyle/>
          <a:p>
            <a:r>
              <a:rPr lang="en-US" sz="1350" dirty="0"/>
              <a:t>*</a:t>
            </a:r>
          </a:p>
        </p:txBody>
      </p:sp>
      <p:sp>
        <p:nvSpPr>
          <p:cNvPr id="10" name="CaixaDeTexto 9">
            <a:extLst>
              <a:ext uri="{FF2B5EF4-FFF2-40B4-BE49-F238E27FC236}">
                <a16:creationId xmlns:a16="http://schemas.microsoft.com/office/drawing/2014/main" id="{53A2FCE1-BBAC-4341-B8DC-B2209493FF77}"/>
              </a:ext>
            </a:extLst>
          </p:cNvPr>
          <p:cNvSpPr txBox="1"/>
          <p:nvPr/>
        </p:nvSpPr>
        <p:spPr>
          <a:xfrm>
            <a:off x="353606" y="4608108"/>
            <a:ext cx="865545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Swimming motility assay of the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tumefaciens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ld-type, </a:t>
            </a:r>
            <a:r>
              <a:rPr lang="en-US" sz="1600" i="1" dirty="0" smtClean="0">
                <a:latin typeface="Calibri" panose="020F0502020204030204" pitchFamily="34" charset="0"/>
                <a:cs typeface="Calibri" panose="020F0502020204030204" pitchFamily="34" charset="0"/>
              </a:rPr>
              <a:t>∆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aAD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600" i="1" dirty="0">
                <a:latin typeface="Calibri" panose="020F0502020204030204" pitchFamily="34" charset="0"/>
                <a:cs typeface="Calibri" panose="020F0502020204030204" pitchFamily="34" charset="0"/>
              </a:rPr>
              <a:t>∆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aABCD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nt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ins, and the mutant strains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lemented with Las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a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mean values ± the standard deviations (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3) are plotted. Mean values were compared to the wild-type, * indicate statistically significant difference (P &lt; 0.05, Student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). WT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tumefacien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ld-type strain carrying the empty vector. </a:t>
            </a:r>
            <a:r>
              <a:rPr lang="en-US" sz="1600" i="1" dirty="0">
                <a:latin typeface="Calibri" panose="020F0502020204030204" pitchFamily="34" charset="0"/>
                <a:cs typeface="Calibri" panose="020F0502020204030204" pitchFamily="34" charset="0"/>
              </a:rPr>
              <a:t>∆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aAD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i="1" dirty="0">
                <a:latin typeface="Calibri" panose="020F0502020204030204" pitchFamily="34" charset="0"/>
                <a:cs typeface="Calibri" panose="020F0502020204030204" pitchFamily="34" charset="0"/>
              </a:rPr>
              <a:t>∆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aABCD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. tumefacien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strains carrying the empty vector. </a:t>
            </a:r>
            <a:r>
              <a:rPr lang="en-US" sz="1600" i="1" dirty="0">
                <a:latin typeface="Calibri" panose="020F0502020204030204" pitchFamily="34" charset="0"/>
                <a:cs typeface="Calibri" panose="020F0502020204030204" pitchFamily="34" charset="0"/>
              </a:rPr>
              <a:t>∆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aAD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aALas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i="1" dirty="0">
                <a:latin typeface="Calibri" panose="020F0502020204030204" pitchFamily="34" charset="0"/>
                <a:cs typeface="Calibri" panose="020F0502020204030204" pitchFamily="34" charset="0"/>
              </a:rPr>
              <a:t>∆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aABCD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aALas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nt strains carrying the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iaticus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aA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. 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502073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</TotalTime>
  <Words>125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axuel Andrade</dc:creator>
  <cp:lastModifiedBy>Wang,Nian</cp:lastModifiedBy>
  <cp:revision>12</cp:revision>
  <dcterms:created xsi:type="dcterms:W3CDTF">2019-10-03T02:05:48Z</dcterms:created>
  <dcterms:modified xsi:type="dcterms:W3CDTF">2019-10-28T13:40:36Z</dcterms:modified>
</cp:coreProperties>
</file>